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24"/>
  </p:normalViewPr>
  <p:slideViewPr>
    <p:cSldViewPr snapToGrid="0">
      <p:cViewPr varScale="1">
        <p:scale>
          <a:sx n="102" d="100"/>
          <a:sy n="102" d="100"/>
        </p:scale>
        <p:origin x="9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D8158C-481B-8742-9DD3-713C071E77B6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478D2F-F455-7249-82ED-78C57FE78E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8949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478D2F-F455-7249-82ED-78C57FE78E5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4151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894FF6-678C-CD54-7B31-5526A8A234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E9B657A-9AB6-6179-30C3-572CDB3947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52340F0-C272-9FC0-022C-51FC23F4F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EC8DDB-9372-7B1B-510B-B914F951B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A22548-73AF-AC22-A29B-5C1066A0D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7960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544A5B-D8D6-22FA-78D9-E5C56881F1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B059182-38F4-E32C-8DD1-225F75010E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D5EB6A-8690-B225-F88B-23562A7C6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03CBCD4-043E-1A78-1C49-4920EED71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B9C6B5-E3EB-FAFB-583A-FA046ABF6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3212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520E30B-3FE7-C800-4F70-0202059C9F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2C79141-BAF0-6183-AE53-E1AB9FB8A6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A78654-BB7E-1E4F-4862-A2A764ADA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693B51-14A4-747F-445D-5CF7374A15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23FCD8-BA0F-8542-9BDB-4D8645D9D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705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53BF64-5FB0-94E1-6947-4992428DD8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9500D70-0484-3F90-5F0E-D511D38B01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1981496-912A-C0D5-4177-84AFAB148D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D905F4-8F6D-06F0-04EC-F871E8FA9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7451D0-3B16-9253-7F8D-EB0E7B176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2285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01C28A-27BE-76B8-C65B-60104A358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411101-161B-DD8C-0B9A-CF0950D265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0DE533-D1E6-89CC-FDE3-BEFF7C212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82D235-509B-41F7-9909-39AC493EA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2D154F-14B8-1189-32C4-51B1D1999F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349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245014-FC7C-D390-6346-E9D3E30B09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74BABDD-B631-6A41-3A27-F7AAE463F5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F5586D3-B4E2-973B-C2BE-962EE70CC3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5954C8-70FB-E023-E78C-1027223D77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67A75AF-6F36-2CAC-CA7C-CE3B25D9E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2A1645F-C02C-2692-D27D-AE00CD5B4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358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993C21-478A-D145-1FC7-E8EBB8D12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B3DCA19-5CB1-2931-C6D8-FC9B265234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A536464-C7DC-E963-5C5B-37C78D65A5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24B6A04-68E0-4457-044E-BC4450A311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94DAC74-2577-EC58-E948-E6D3A132F2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F3863A4-4BE9-8B24-0E8C-ABBD161593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65A1AFB-3481-F888-85DC-04D08594D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ADAA5DC-D93F-0176-C774-5634A2A9D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482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349499-761A-CE33-2F26-A60587EF1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F87B4E8-D646-F97C-3B0B-638B0343E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1A36937-ADB7-E513-CCF9-670A4230B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ED27EA2-AC0E-578C-7820-9EF96F27E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719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4DA93BC-54ED-9502-7D19-31A89CE1E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AA2E87F-9932-A926-EA90-6B3D51DB5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5158913-ACE2-D7BC-5217-05010539E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172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43AD50-FA4A-8770-DB7B-A97AE0FD38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5AB9250-1113-FAAD-3FC9-4CD96A99C1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215BC14-9F6E-89B7-5784-0693B568AE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6E057A2-346E-F646-986A-02BE8078E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FF10D66-860B-4EAA-718C-D08B42FE3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BFC72FF-299B-5DF0-E375-182D00FBD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3075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009289-7953-7FB0-C337-0AED210442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3F3DB47-024A-56D7-5653-74B44BBAED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6D932A5-A1A2-7254-1722-CF128F9CAD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3DC8705-6BB2-1325-1A70-4F20E915AD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172F64-D9AD-3435-7375-32322D7C6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49DDE2F-FF5F-4888-B0F1-B8FF5E973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2956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4D8011A-85FB-6E5F-EC83-B07A31E6FE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F57A3CB-9365-5E68-CB89-1A9B3B5048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17729B8-C7CB-58A5-2B82-B0B514AD27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A2E23-37E3-A94E-8F35-E1584B08AA8A}" type="datetimeFigureOut">
              <a:rPr kumimoji="1" lang="ja-JP" altLang="en-US" smtClean="0"/>
              <a:t>2023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13C18B-D054-31A1-2293-8C74EC9BAC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C92C75-1FFF-5AEA-A452-7D154AF56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916405-7C90-1F4F-B7CC-68021E5B0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3154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7F0E7FB-EB11-2A41-168E-ED2ED18A7BFB}"/>
              </a:ext>
            </a:extLst>
          </p:cNvPr>
          <p:cNvSpPr txBox="1"/>
          <p:nvPr/>
        </p:nvSpPr>
        <p:spPr>
          <a:xfrm>
            <a:off x="-1" y="5954241"/>
            <a:ext cx="12463387" cy="8835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tabLst>
                <a:tab pos="1011555" algn="l"/>
              </a:tabLst>
            </a:pPr>
            <a:r>
              <a:rPr lang="en-US" altLang="ja-JP" b="1" dirty="0">
                <a:latin typeface="Arial" panose="020B0604020202020204" pitchFamily="34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Supplemental figure 1.</a:t>
            </a:r>
            <a:r>
              <a:rPr lang="en-US" altLang="ja-JP" sz="2000" b="1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latin typeface="Arial" panose="020B0604020202020204" pitchFamily="34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esection </a:t>
            </a:r>
            <a:r>
              <a:rPr lang="en-US" altLang="ja-JP" sz="1800" b="1" dirty="0"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specimen for partial hepatectomy. </a:t>
            </a:r>
            <a:endParaRPr lang="en-US" altLang="ja-JP" sz="1600" b="1" dirty="0"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tabLst>
                <a:tab pos="1011555" algn="l"/>
              </a:tabLst>
            </a:pPr>
            <a:r>
              <a:rPr lang="en-US" altLang="ja-JP" sz="16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he yellow arrow indicates the lesion of cholangiocarcinoma </a:t>
            </a:r>
            <a:r>
              <a:rPr lang="en-US" altLang="ja-JP" sz="1600" dirty="0"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(A)</a:t>
            </a:r>
            <a:r>
              <a:rPr lang="en-US" altLang="ja-JP" sz="16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. The </a:t>
            </a:r>
            <a:r>
              <a:rPr lang="en-US" altLang="ja-JP" sz="16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athological diagnosis was </a:t>
            </a:r>
            <a:r>
              <a:rPr lang="en-US" altLang="ja-JP" sz="16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deno</a:t>
            </a:r>
            <a:r>
              <a:rPr lang="en-US" altLang="ja-JP" sz="16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arcinoma (B,C). </a:t>
            </a:r>
            <a:endParaRPr lang="ja-JP" altLang="ja-JP" sz="160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19" name="図 18" descr="パソコンの画面&#10;&#10;低い精度で自動的に生成された説明">
            <a:extLst>
              <a:ext uri="{FF2B5EF4-FFF2-40B4-BE49-F238E27FC236}">
                <a16:creationId xmlns:a16="http://schemas.microsoft.com/office/drawing/2014/main" id="{2CDE63D9-0253-C6A2-616F-D47B81A4D84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609"/>
          <a:stretch/>
        </p:blipFill>
        <p:spPr>
          <a:xfrm>
            <a:off x="872093" y="37864"/>
            <a:ext cx="4861958" cy="3035510"/>
          </a:xfrm>
          <a:prstGeom prst="rect">
            <a:avLst/>
          </a:prstGeom>
        </p:spPr>
      </p:pic>
      <p:sp>
        <p:nvSpPr>
          <p:cNvPr id="4" name="右矢印 3">
            <a:extLst>
              <a:ext uri="{FF2B5EF4-FFF2-40B4-BE49-F238E27FC236}">
                <a16:creationId xmlns:a16="http://schemas.microsoft.com/office/drawing/2014/main" id="{2015D40F-F935-8EE3-19E5-B5DAC1967422}"/>
              </a:ext>
            </a:extLst>
          </p:cNvPr>
          <p:cNvSpPr/>
          <p:nvPr/>
        </p:nvSpPr>
        <p:spPr>
          <a:xfrm rot="13164512">
            <a:off x="3611382" y="1943082"/>
            <a:ext cx="978408" cy="484632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5" name="図 34">
            <a:extLst>
              <a:ext uri="{FF2B5EF4-FFF2-40B4-BE49-F238E27FC236}">
                <a16:creationId xmlns:a16="http://schemas.microsoft.com/office/drawing/2014/main" id="{B4D66A90-B713-66CF-7B31-1147ECED1E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93302" y="3109910"/>
            <a:ext cx="5183733" cy="2915850"/>
          </a:xfrm>
          <a:prstGeom prst="rect">
            <a:avLst/>
          </a:prstGeom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3B1FEC1-C015-8655-35C5-D4E3F9EB485F}"/>
              </a:ext>
            </a:extLst>
          </p:cNvPr>
          <p:cNvSpPr txBox="1"/>
          <p:nvPr/>
        </p:nvSpPr>
        <p:spPr>
          <a:xfrm>
            <a:off x="10820502" y="5619182"/>
            <a:ext cx="486030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μm</a:t>
            </a:r>
            <a:endParaRPr kumimoji="1" lang="ja-JP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A761D9DD-FAA7-E387-64DF-E46089DAC296}"/>
              </a:ext>
            </a:extLst>
          </p:cNvPr>
          <p:cNvCxnSpPr>
            <a:cxnSpLocks/>
          </p:cNvCxnSpPr>
          <p:nvPr/>
        </p:nvCxnSpPr>
        <p:spPr>
          <a:xfrm>
            <a:off x="10697036" y="5870535"/>
            <a:ext cx="728244" cy="0"/>
          </a:xfrm>
          <a:prstGeom prst="line">
            <a:avLst/>
          </a:prstGeom>
          <a:ln w="38100" cap="flat">
            <a:round/>
            <a:tailEnd type="non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B374F0CA-3D1D-6326-238B-085A11C4B714}"/>
              </a:ext>
            </a:extLst>
          </p:cNvPr>
          <p:cNvCxnSpPr>
            <a:cxnSpLocks/>
          </p:cNvCxnSpPr>
          <p:nvPr/>
        </p:nvCxnSpPr>
        <p:spPr>
          <a:xfrm flipV="1">
            <a:off x="11425280" y="5811688"/>
            <a:ext cx="0" cy="123110"/>
          </a:xfrm>
          <a:prstGeom prst="line">
            <a:avLst/>
          </a:prstGeom>
          <a:ln w="38100" cap="flat">
            <a:round/>
            <a:tailEnd type="non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BAF5E638-2BF4-F8A6-F329-B3C1CD3CFFF5}"/>
              </a:ext>
            </a:extLst>
          </p:cNvPr>
          <p:cNvCxnSpPr>
            <a:cxnSpLocks/>
          </p:cNvCxnSpPr>
          <p:nvPr/>
        </p:nvCxnSpPr>
        <p:spPr>
          <a:xfrm flipV="1">
            <a:off x="10701753" y="5811688"/>
            <a:ext cx="0" cy="123110"/>
          </a:xfrm>
          <a:prstGeom prst="line">
            <a:avLst/>
          </a:prstGeom>
          <a:ln w="38100" cap="flat">
            <a:round/>
            <a:tailEnd type="non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40" name="図 39" descr="衣料, 敷物 が含まれている画像&#10;&#10;自動的に生成された説明">
            <a:extLst>
              <a:ext uri="{FF2B5EF4-FFF2-40B4-BE49-F238E27FC236}">
                <a16:creationId xmlns:a16="http://schemas.microsoft.com/office/drawing/2014/main" id="{F54EBB36-2DDD-9236-0C9A-CF9A0DB0D3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79801" y="37864"/>
            <a:ext cx="5183734" cy="2915850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24AA1A2-DF0C-2373-2B95-09855A88817F}"/>
              </a:ext>
            </a:extLst>
          </p:cNvPr>
          <p:cNvSpPr txBox="1"/>
          <p:nvPr/>
        </p:nvSpPr>
        <p:spPr>
          <a:xfrm>
            <a:off x="10883201" y="2558855"/>
            <a:ext cx="550151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100μm</a:t>
            </a:r>
            <a:endParaRPr kumimoji="1" lang="ja-JP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B3EB6714-D2E4-4C01-4E1F-35EDADF010DD}"/>
              </a:ext>
            </a:extLst>
          </p:cNvPr>
          <p:cNvCxnSpPr>
            <a:cxnSpLocks/>
          </p:cNvCxnSpPr>
          <p:nvPr/>
        </p:nvCxnSpPr>
        <p:spPr>
          <a:xfrm>
            <a:off x="10781103" y="2799630"/>
            <a:ext cx="738937" cy="0"/>
          </a:xfrm>
          <a:prstGeom prst="line">
            <a:avLst/>
          </a:prstGeom>
          <a:ln w="38100" cap="flat">
            <a:round/>
            <a:tailEnd type="non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DB86354A-3EBC-5E5B-AA8D-3E31FE1BFD87}"/>
              </a:ext>
            </a:extLst>
          </p:cNvPr>
          <p:cNvCxnSpPr>
            <a:cxnSpLocks/>
          </p:cNvCxnSpPr>
          <p:nvPr/>
        </p:nvCxnSpPr>
        <p:spPr>
          <a:xfrm flipV="1">
            <a:off x="11523502" y="2738075"/>
            <a:ext cx="0" cy="123110"/>
          </a:xfrm>
          <a:prstGeom prst="line">
            <a:avLst/>
          </a:prstGeom>
          <a:ln w="38100" cap="flat">
            <a:round/>
            <a:tailEnd type="non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99B9E704-2508-C252-61C6-D323A56C984D}"/>
              </a:ext>
            </a:extLst>
          </p:cNvPr>
          <p:cNvCxnSpPr>
            <a:cxnSpLocks/>
          </p:cNvCxnSpPr>
          <p:nvPr/>
        </p:nvCxnSpPr>
        <p:spPr>
          <a:xfrm flipV="1">
            <a:off x="10785820" y="2740783"/>
            <a:ext cx="0" cy="123110"/>
          </a:xfrm>
          <a:prstGeom prst="line">
            <a:avLst/>
          </a:prstGeom>
          <a:ln w="38100" cap="flat">
            <a:round/>
            <a:tailEnd type="non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B9AE9840-0909-C8BB-4B61-8309D9DF1188}"/>
              </a:ext>
            </a:extLst>
          </p:cNvPr>
          <p:cNvGrpSpPr/>
          <p:nvPr/>
        </p:nvGrpSpPr>
        <p:grpSpPr>
          <a:xfrm>
            <a:off x="1907382" y="3784627"/>
            <a:ext cx="2643187" cy="1762124"/>
            <a:chOff x="5700713" y="3719514"/>
            <a:chExt cx="2643187" cy="1762124"/>
          </a:xfrm>
        </p:grpSpPr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9E76808A-392C-C474-39B8-6115866B8DC3}"/>
                </a:ext>
              </a:extLst>
            </p:cNvPr>
            <p:cNvCxnSpPr>
              <a:cxnSpLocks/>
            </p:cNvCxnSpPr>
            <p:nvPr/>
          </p:nvCxnSpPr>
          <p:spPr>
            <a:xfrm>
              <a:off x="5700713" y="4600576"/>
              <a:ext cx="2643187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6A096083-2E89-8B7D-DA64-5D1B3EE75E3F}"/>
                </a:ext>
              </a:extLst>
            </p:cNvPr>
            <p:cNvCxnSpPr>
              <a:cxnSpLocks/>
            </p:cNvCxnSpPr>
            <p:nvPr/>
          </p:nvCxnSpPr>
          <p:spPr>
            <a:xfrm>
              <a:off x="7024688" y="3719514"/>
              <a:ext cx="0" cy="1762124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4B6BCBED-AEBF-AFF8-0750-BA1B627B63C7}"/>
                </a:ext>
              </a:extLst>
            </p:cNvPr>
            <p:cNvSpPr txBox="1"/>
            <p:nvPr/>
          </p:nvSpPr>
          <p:spPr>
            <a:xfrm>
              <a:off x="6096000" y="3800589"/>
              <a:ext cx="48122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3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AE834242-9629-C112-4259-184C044B539E}"/>
                </a:ext>
              </a:extLst>
            </p:cNvPr>
            <p:cNvSpPr txBox="1"/>
            <p:nvPr/>
          </p:nvSpPr>
          <p:spPr>
            <a:xfrm>
              <a:off x="7496721" y="3800588"/>
              <a:ext cx="48122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3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10E2509C-D517-3801-BA72-EB090056BCB3}"/>
                </a:ext>
              </a:extLst>
            </p:cNvPr>
            <p:cNvSpPr txBox="1"/>
            <p:nvPr/>
          </p:nvSpPr>
          <p:spPr>
            <a:xfrm>
              <a:off x="7505073" y="4774006"/>
              <a:ext cx="48122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3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42AF424-A4A2-1C1D-3608-FE960AEE7AC1}"/>
              </a:ext>
            </a:extLst>
          </p:cNvPr>
          <p:cNvSpPr txBox="1"/>
          <p:nvPr/>
        </p:nvSpPr>
        <p:spPr>
          <a:xfrm>
            <a:off x="6495529" y="2518264"/>
            <a:ext cx="869149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544DBCD-ACEA-37D3-5D25-47E2B439E0B0}"/>
              </a:ext>
            </a:extLst>
          </p:cNvPr>
          <p:cNvSpPr txBox="1"/>
          <p:nvPr/>
        </p:nvSpPr>
        <p:spPr>
          <a:xfrm>
            <a:off x="6498417" y="5598557"/>
            <a:ext cx="869149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8980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5</TotalTime>
  <Words>41</Words>
  <Application>Microsoft Macintosh PowerPoint</Application>
  <PresentationFormat>ワイド画面</PresentationFormat>
  <Paragraphs>1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htsu akira</dc:creator>
  <cp:lastModifiedBy>ohtsu akira</cp:lastModifiedBy>
  <cp:revision>38</cp:revision>
  <dcterms:created xsi:type="dcterms:W3CDTF">2022-10-26T02:33:44Z</dcterms:created>
  <dcterms:modified xsi:type="dcterms:W3CDTF">2023-03-11T06:56:12Z</dcterms:modified>
</cp:coreProperties>
</file>